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322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D73C0C-885C-4922-8C80-8DA8B5F8A46B}" type="datetimeFigureOut">
              <a:rPr lang="en-GB" smtClean="0"/>
              <a:t>18/11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DF779E-D821-46D5-8481-6145B2FB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373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F779E-D821-46D5-8481-6145B2FB119B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44316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DF779E-D821-46D5-8481-6145B2FB119B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4228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45AD6-66AE-442E-BA00-74E7C2C6ABA8}" type="datetime1">
              <a:rPr lang="en-GB" smtClean="0"/>
              <a:t>18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505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9B0A-E207-48FD-BAD4-B4E3BD6F07A4}" type="datetime1">
              <a:rPr lang="en-GB" smtClean="0"/>
              <a:t>18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690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A2B81-A9D4-41A1-97AC-040FDAD4CBD0}" type="datetime1">
              <a:rPr lang="en-GB" smtClean="0"/>
              <a:t>18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492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26020-99B2-45EF-BAC4-B1746CBD8743}" type="datetime1">
              <a:rPr lang="en-GB" smtClean="0"/>
              <a:t>18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110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A5C0E-C63B-4AEE-B25E-326F22E73117}" type="datetime1">
              <a:rPr lang="en-GB" smtClean="0"/>
              <a:t>18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2371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7C364-4142-4977-83F6-72DCF5A9694C}" type="datetime1">
              <a:rPr lang="en-GB" smtClean="0"/>
              <a:t>18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635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9FCD2-E04E-45E4-945B-940C41A23D0D}" type="datetime1">
              <a:rPr lang="en-GB" smtClean="0"/>
              <a:t>18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61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6F8-23D5-4AD0-B484-631389E368C6}" type="datetime1">
              <a:rPr lang="en-GB" smtClean="0"/>
              <a:t>18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196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FBED3-AC98-4B04-9BAD-795CE6E97AFE}" type="datetime1">
              <a:rPr lang="en-GB" smtClean="0"/>
              <a:t>18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009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0683-BF9B-4AAF-B59F-E07D4B13D542}" type="datetime1">
              <a:rPr lang="en-GB" smtClean="0"/>
              <a:t>18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1978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32992-8501-4053-A9BE-0582ECC0FA01}" type="datetime1">
              <a:rPr lang="en-GB" smtClean="0"/>
              <a:t>18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4486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E4C87-A08C-48FF-B9DC-8EF322C905CC}" type="datetime1">
              <a:rPr lang="en-GB" smtClean="0"/>
              <a:t>18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A7BCF-69C0-4743-AF84-2B31B9F131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663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f"/><Relationship Id="rId3" Type="http://schemas.openxmlformats.org/officeDocument/2006/relationships/image" Target="../media/image19.tiff"/><Relationship Id="rId7" Type="http://schemas.openxmlformats.org/officeDocument/2006/relationships/image" Target="../media/image2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7" Type="http://schemas.openxmlformats.org/officeDocument/2006/relationships/image" Target="../media/image30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tiff"/><Relationship Id="rId5" Type="http://schemas.openxmlformats.org/officeDocument/2006/relationships/image" Target="../media/image28.tiff"/><Relationship Id="rId4" Type="http://schemas.openxmlformats.org/officeDocument/2006/relationships/image" Target="../media/image2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7" Type="http://schemas.openxmlformats.org/officeDocument/2006/relationships/image" Target="../media/image36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tiff"/><Relationship Id="rId5" Type="http://schemas.openxmlformats.org/officeDocument/2006/relationships/image" Target="../media/image34.tiff"/><Relationship Id="rId4" Type="http://schemas.openxmlformats.org/officeDocument/2006/relationships/image" Target="../media/image33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7" Type="http://schemas.openxmlformats.org/officeDocument/2006/relationships/image" Target="../media/image42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tiff"/><Relationship Id="rId5" Type="http://schemas.openxmlformats.org/officeDocument/2006/relationships/image" Target="../media/image40.tiff"/><Relationship Id="rId4" Type="http://schemas.openxmlformats.org/officeDocument/2006/relationships/image" Target="../media/image39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tiff"/><Relationship Id="rId3" Type="http://schemas.openxmlformats.org/officeDocument/2006/relationships/image" Target="../media/image43.tiff"/><Relationship Id="rId7" Type="http://schemas.openxmlformats.org/officeDocument/2006/relationships/image" Target="../media/image4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6.tiff"/><Relationship Id="rId5" Type="http://schemas.openxmlformats.org/officeDocument/2006/relationships/image" Target="../media/image45.tiff"/><Relationship Id="rId4" Type="http://schemas.openxmlformats.org/officeDocument/2006/relationships/image" Target="../media/image4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1912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CR siRNA - Basal </a:t>
            </a:r>
            <a:endParaRPr lang="en-GB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" y="2564904"/>
            <a:ext cx="4106686" cy="136803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" y="4005184"/>
            <a:ext cx="4106686" cy="136803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" y="1136246"/>
            <a:ext cx="4106686" cy="136803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9548" y="4005184"/>
            <a:ext cx="4106686" cy="136803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778" y="2564904"/>
            <a:ext cx="4106686" cy="136803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778" y="1136246"/>
            <a:ext cx="4106686" cy="1368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5175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19367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CR siRNA - Insulin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359" y="980880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2493048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144" y="4005216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0871" y="4005216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2" y="2493048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2" y="980880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4962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2192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VAMP3 siRNA - Basal 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2" y="2626378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3" y="4144928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3" y="1125993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0" y="4149080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5" y="2660658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1" y="1156224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0883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2321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VAMP3 siRNA - Insulin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3" y="991409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0" y="2496770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4002833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2" y="4005064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5958" y="2493048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2" y="987961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95097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2192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VAMP5 siRNA - Basal 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47" y="1340768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603" y="2852936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48" y="4365104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614" y="4339344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7362" y="2872814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7361" y="1344419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27094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2268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VAMP5 siRNA - Insulin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1291612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2739961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3" y="4224942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0566" y="4221088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0567" y="2739961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2393" y="1287961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99781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2192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VAMP7 siRNA - Basal 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393" y="1137961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393" y="2589961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393" y="4077072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3427" y="4077072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3427" y="2589961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3427" y="1137961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03413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mtClean="0"/>
              <a:t>SiRNA 17.11.14</a:t>
            </a: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67544" y="260648"/>
            <a:ext cx="2268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VAMP7 siRNA - Insulin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1371961"/>
            <a:ext cx="4106591" cy="136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3" y="2848792"/>
            <a:ext cx="4106591" cy="1368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4391183"/>
            <a:ext cx="4106591" cy="1368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7484" y="4365104"/>
            <a:ext cx="4106591" cy="136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2" y="2848792"/>
            <a:ext cx="4106591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592" y="1371961"/>
            <a:ext cx="4106591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8754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0</Words>
  <Application>Microsoft Office PowerPoint</Application>
  <PresentationFormat>On-screen Show (4:3)</PresentationFormat>
  <Paragraphs>18</Paragraphs>
  <Slides>8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Sadler</dc:creator>
  <cp:lastModifiedBy>Jessica Sadler</cp:lastModifiedBy>
  <cp:revision>4</cp:revision>
  <dcterms:created xsi:type="dcterms:W3CDTF">2014-11-18T13:43:22Z</dcterms:created>
  <dcterms:modified xsi:type="dcterms:W3CDTF">2014-11-18T14:00:27Z</dcterms:modified>
</cp:coreProperties>
</file>